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75" r:id="rId3"/>
    <p:sldId id="258" r:id="rId4"/>
    <p:sldId id="274" r:id="rId5"/>
    <p:sldId id="289" r:id="rId6"/>
  </p:sldIdLst>
  <p:sldSz cx="6858000" cy="9144000" type="screen4x3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E68EDE62-B960-4F15-83B3-276C41E2A99E}">
          <p14:sldIdLst>
            <p14:sldId id="257"/>
            <p14:sldId id="275"/>
            <p14:sldId id="258"/>
            <p14:sldId id="274"/>
            <p14:sldId id="28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hmitt, Claus Peter" initials="SCP" lastIdx="1" clrIdx="0">
    <p:extLst>
      <p:ext uri="{19B8F6BF-5375-455C-9EA6-DF929625EA0E}">
        <p15:presenceInfo xmlns:p15="http://schemas.microsoft.com/office/powerpoint/2012/main" userId="Schmitt, Claus Pet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516" autoAdjust="0"/>
    <p:restoredTop sz="94660"/>
  </p:normalViewPr>
  <p:slideViewPr>
    <p:cSldViewPr snapToGrid="0">
      <p:cViewPr varScale="1">
        <p:scale>
          <a:sx n="84" d="100"/>
          <a:sy n="84" d="100"/>
        </p:scale>
        <p:origin x="3324" y="84"/>
      </p:cViewPr>
      <p:guideLst>
        <p:guide orient="horz" pos="285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18967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03328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30601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66006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28495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5345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1833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52874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64777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19451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17887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0B8F15-C0D2-43B6-94E5-81F86E2CF935}" type="datetimeFigureOut">
              <a:rPr lang="en-GB" smtClean="0"/>
              <a:t>24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BCDDA-B6AA-408B-9065-FF771758F701}" type="slidenum">
              <a:rPr lang="en-GB" smtClean="0"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9467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8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emf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7" Type="http://schemas.openxmlformats.org/officeDocument/2006/relationships/image" Target="../media/image1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14.bin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8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5" Type="http://schemas.openxmlformats.org/officeDocument/2006/relationships/image" Target="../media/image7.emf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17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oleObject" Target="../embeddings/oleObject20.bin"/><Relationship Id="rId18" Type="http://schemas.openxmlformats.org/officeDocument/2006/relationships/image" Target="../media/image25.e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22.emf"/><Relationship Id="rId17" Type="http://schemas.openxmlformats.org/officeDocument/2006/relationships/oleObject" Target="../embeddings/oleObject2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4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19.emf"/><Relationship Id="rId11" Type="http://schemas.openxmlformats.org/officeDocument/2006/relationships/oleObject" Target="../embeddings/oleObject19.bin"/><Relationship Id="rId5" Type="http://schemas.openxmlformats.org/officeDocument/2006/relationships/oleObject" Target="../embeddings/oleObject16.bin"/><Relationship Id="rId15" Type="http://schemas.openxmlformats.org/officeDocument/2006/relationships/oleObject" Target="../embeddings/oleObject21.bin"/><Relationship Id="rId10" Type="http://schemas.openxmlformats.org/officeDocument/2006/relationships/image" Target="../media/image21.emf"/><Relationship Id="rId4" Type="http://schemas.openxmlformats.org/officeDocument/2006/relationships/image" Target="../media/image18.emf"/><Relationship Id="rId9" Type="http://schemas.openxmlformats.org/officeDocument/2006/relationships/oleObject" Target="../embeddings/oleObject18.bin"/><Relationship Id="rId14" Type="http://schemas.openxmlformats.org/officeDocument/2006/relationships/image" Target="../media/image2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79B0C73F-97D7-45C5-9C65-AEA6E20CE040}"/>
              </a:ext>
            </a:extLst>
          </p:cNvPr>
          <p:cNvSpPr txBox="1"/>
          <p:nvPr/>
        </p:nvSpPr>
        <p:spPr>
          <a:xfrm>
            <a:off x="278141" y="7716352"/>
            <a:ext cx="622131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. Fig 1: Body weight, energy and liquid intake of diabetic WT and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KO mice (normal and high fat diet)</a:t>
            </a:r>
          </a:p>
          <a:p>
            <a:pPr algn="just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verage body weight (after 5 h of fasting) is increased in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 mice under ND and decreased under STZ-treatment (A). Energy intake (B) and liquid intake (C) is increased under normal diet and high fat diet in STZ-treated mice, displayed as mean ± SD. For energy and liquid intake five measurement timepoints were used. Group size n=6-11. *=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≤0.05, **=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≤0.01, ***=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≤0.001, ****=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&lt;0.0001 (One-way ANOVA with Tukey test)</a:t>
            </a:r>
            <a:r>
              <a:rPr lang="en-GB" sz="1000" dirty="0"/>
              <a:t>.</a:t>
            </a: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Objekt 26">
            <a:extLst>
              <a:ext uri="{FF2B5EF4-FFF2-40B4-BE49-F238E27FC236}">
                <a16:creationId xmlns:a16="http://schemas.microsoft.com/office/drawing/2014/main" id="{4BB8FC5C-F156-436C-BC15-4ADB0B01ED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8182841"/>
              </p:ext>
            </p:extLst>
          </p:nvPr>
        </p:nvGraphicFramePr>
        <p:xfrm>
          <a:off x="3470275" y="1406525"/>
          <a:ext cx="3187700" cy="1220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4" name="Prism 9" r:id="rId3" imgW="7592381" imgH="2916527" progId="Prism9.Document">
                  <p:embed/>
                </p:oleObj>
              </mc:Choice>
              <mc:Fallback>
                <p:oleObj name="Prism 9" r:id="rId3" imgW="7592381" imgH="2916527" progId="Prism9.Document">
                  <p:embed/>
                  <p:pic>
                    <p:nvPicPr>
                      <p:cNvPr id="27" name="Objekt 26">
                        <a:extLst>
                          <a:ext uri="{FF2B5EF4-FFF2-40B4-BE49-F238E27FC236}">
                            <a16:creationId xmlns:a16="http://schemas.microsoft.com/office/drawing/2014/main" id="{4BB8FC5C-F156-436C-BC15-4ADB0B01ED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70275" y="1406525"/>
                        <a:ext cx="3187700" cy="1220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feld 13">
            <a:extLst>
              <a:ext uri="{FF2B5EF4-FFF2-40B4-BE49-F238E27FC236}">
                <a16:creationId xmlns:a16="http://schemas.microsoft.com/office/drawing/2014/main" id="{4C937B88-A7AF-4AA4-9EC6-F55896E6A13A}"/>
              </a:ext>
            </a:extLst>
          </p:cNvPr>
          <p:cNvSpPr txBox="1"/>
          <p:nvPr/>
        </p:nvSpPr>
        <p:spPr>
          <a:xfrm>
            <a:off x="195340" y="10985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FD966A24-0020-4E87-A712-452914E526AA}"/>
              </a:ext>
            </a:extLst>
          </p:cNvPr>
          <p:cNvSpPr txBox="1"/>
          <p:nvPr/>
        </p:nvSpPr>
        <p:spPr>
          <a:xfrm>
            <a:off x="195340" y="292853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242C6555-B7AF-4693-94E2-7B8416CBE190}"/>
              </a:ext>
            </a:extLst>
          </p:cNvPr>
          <p:cNvSpPr txBox="1"/>
          <p:nvPr/>
        </p:nvSpPr>
        <p:spPr>
          <a:xfrm>
            <a:off x="233451" y="492959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1BF92C8E-3909-4EFA-97A5-501BAD251E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2982240"/>
              </p:ext>
            </p:extLst>
          </p:nvPr>
        </p:nvGraphicFramePr>
        <p:xfrm>
          <a:off x="503238" y="2579688"/>
          <a:ext cx="1820862" cy="2352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5" name="Prism 9" r:id="rId5" imgW="3591994" imgH="4482477" progId="Prism9.Document">
                  <p:embed/>
                </p:oleObj>
              </mc:Choice>
              <mc:Fallback>
                <p:oleObj name="Prism 9" r:id="rId5" imgW="3591994" imgH="4482477" progId="Prism9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1BF92C8E-3909-4EFA-97A5-501BAD251E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03238" y="2579688"/>
                        <a:ext cx="1820862" cy="2352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kt 31">
            <a:extLst>
              <a:ext uri="{FF2B5EF4-FFF2-40B4-BE49-F238E27FC236}">
                <a16:creationId xmlns:a16="http://schemas.microsoft.com/office/drawing/2014/main" id="{A6DBA571-CF51-482A-9EEC-7079A0BA11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5079512"/>
              </p:ext>
            </p:extLst>
          </p:nvPr>
        </p:nvGraphicFramePr>
        <p:xfrm>
          <a:off x="3803650" y="2517775"/>
          <a:ext cx="1930400" cy="2554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6" name="Prism 9" r:id="rId7" imgW="3765579" imgH="4978049" progId="Prism9.Document">
                  <p:embed/>
                </p:oleObj>
              </mc:Choice>
              <mc:Fallback>
                <p:oleObj name="Prism 9" r:id="rId7" imgW="3765579" imgH="4978049" progId="Prism9.Document">
                  <p:embed/>
                  <p:pic>
                    <p:nvPicPr>
                      <p:cNvPr id="32" name="Objekt 31">
                        <a:extLst>
                          <a:ext uri="{FF2B5EF4-FFF2-40B4-BE49-F238E27FC236}">
                            <a16:creationId xmlns:a16="http://schemas.microsoft.com/office/drawing/2014/main" id="{A6DBA571-CF51-482A-9EEC-7079A0BA11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03650" y="2517775"/>
                        <a:ext cx="1930400" cy="2554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kt 32">
            <a:extLst>
              <a:ext uri="{FF2B5EF4-FFF2-40B4-BE49-F238E27FC236}">
                <a16:creationId xmlns:a16="http://schemas.microsoft.com/office/drawing/2014/main" id="{CA730FDA-5565-424C-9CE8-903C07ABA7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4859471"/>
              </p:ext>
            </p:extLst>
          </p:nvPr>
        </p:nvGraphicFramePr>
        <p:xfrm>
          <a:off x="476250" y="4854575"/>
          <a:ext cx="1879600" cy="2462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7" name="Prism 9" r:id="rId9" imgW="3591994" imgH="4705052" progId="Prism9.Document">
                  <p:embed/>
                </p:oleObj>
              </mc:Choice>
              <mc:Fallback>
                <p:oleObj name="Prism 9" r:id="rId9" imgW="3591994" imgH="4705052" progId="Prism9.Document">
                  <p:embed/>
                  <p:pic>
                    <p:nvPicPr>
                      <p:cNvPr id="33" name="Objekt 32">
                        <a:extLst>
                          <a:ext uri="{FF2B5EF4-FFF2-40B4-BE49-F238E27FC236}">
                            <a16:creationId xmlns:a16="http://schemas.microsoft.com/office/drawing/2014/main" id="{CA730FDA-5565-424C-9CE8-903C07ABA7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6250" y="4854575"/>
                        <a:ext cx="1879600" cy="2462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kt 33">
            <a:extLst>
              <a:ext uri="{FF2B5EF4-FFF2-40B4-BE49-F238E27FC236}">
                <a16:creationId xmlns:a16="http://schemas.microsoft.com/office/drawing/2014/main" id="{59335775-401F-4922-9CB4-DE4B48FD82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8294829"/>
              </p:ext>
            </p:extLst>
          </p:nvPr>
        </p:nvGraphicFramePr>
        <p:xfrm>
          <a:off x="3778250" y="5249863"/>
          <a:ext cx="1958975" cy="2243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8" name="Prism 9" r:id="rId11" imgW="3765579" imgH="4308523" progId="Prism9.Document">
                  <p:embed/>
                </p:oleObj>
              </mc:Choice>
              <mc:Fallback>
                <p:oleObj name="Prism 9" r:id="rId11" imgW="3765579" imgH="4308523" progId="Prism9.Document">
                  <p:embed/>
                  <p:pic>
                    <p:nvPicPr>
                      <p:cNvPr id="34" name="Objekt 33">
                        <a:extLst>
                          <a:ext uri="{FF2B5EF4-FFF2-40B4-BE49-F238E27FC236}">
                            <a16:creationId xmlns:a16="http://schemas.microsoft.com/office/drawing/2014/main" id="{59335775-401F-4922-9CB4-DE4B48FD82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778250" y="5249863"/>
                        <a:ext cx="1958975" cy="2243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kt 23">
            <a:extLst>
              <a:ext uri="{FF2B5EF4-FFF2-40B4-BE49-F238E27FC236}">
                <a16:creationId xmlns:a16="http://schemas.microsoft.com/office/drawing/2014/main" id="{570B5DCE-5052-4278-AA70-C15BE5B9A1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2854621"/>
              </p:ext>
            </p:extLst>
          </p:nvPr>
        </p:nvGraphicFramePr>
        <p:xfrm>
          <a:off x="166688" y="1420813"/>
          <a:ext cx="3262312" cy="1211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99" name="Prism 9" r:id="rId13" imgW="7583378" imgH="2828290" progId="Prism9.Document">
                  <p:embed/>
                </p:oleObj>
              </mc:Choice>
              <mc:Fallback>
                <p:oleObj name="Prism 9" r:id="rId13" imgW="7583378" imgH="2828290" progId="Prism9.Document">
                  <p:embed/>
                  <p:pic>
                    <p:nvPicPr>
                      <p:cNvPr id="24" name="Objekt 23">
                        <a:extLst>
                          <a:ext uri="{FF2B5EF4-FFF2-40B4-BE49-F238E27FC236}">
                            <a16:creationId xmlns:a16="http://schemas.microsoft.com/office/drawing/2014/main" id="{570B5DCE-5052-4278-AA70-C15BE5B9A1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66688" y="1420813"/>
                        <a:ext cx="3262312" cy="1211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FBB73202-2807-FB87-B3A8-843B8ED0F853}"/>
              </a:ext>
            </a:extLst>
          </p:cNvPr>
          <p:cNvGrpSpPr/>
          <p:nvPr/>
        </p:nvGrpSpPr>
        <p:grpSpPr>
          <a:xfrm>
            <a:off x="2239774" y="231846"/>
            <a:ext cx="4299249" cy="814285"/>
            <a:chOff x="2503673" y="138702"/>
            <a:chExt cx="4299249" cy="814285"/>
          </a:xfrm>
        </p:grpSpPr>
        <p:pic>
          <p:nvPicPr>
            <p:cNvPr id="28" name="Grafik 27">
              <a:extLst>
                <a:ext uri="{FF2B5EF4-FFF2-40B4-BE49-F238E27FC236}">
                  <a16:creationId xmlns:a16="http://schemas.microsoft.com/office/drawing/2014/main" id="{E6413941-EF69-46D4-B7CA-854AB1C3D4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76039" t="10492" b="52324"/>
            <a:stretch/>
          </p:blipFill>
          <p:spPr>
            <a:xfrm>
              <a:off x="5607307" y="284609"/>
              <a:ext cx="1195615" cy="617091"/>
            </a:xfrm>
            <a:prstGeom prst="rect">
              <a:avLst/>
            </a:prstGeom>
          </p:spPr>
        </p:pic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5FEEBE99-DE33-F1CA-7C2C-E546A6EB4E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81117" b="51423"/>
            <a:stretch/>
          </p:blipFill>
          <p:spPr>
            <a:xfrm>
              <a:off x="2503673" y="138702"/>
              <a:ext cx="1025693" cy="81428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162275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feld 43">
            <a:extLst>
              <a:ext uri="{FF2B5EF4-FFF2-40B4-BE49-F238E27FC236}">
                <a16:creationId xmlns:a16="http://schemas.microsoft.com/office/drawing/2014/main" id="{D729B277-80AE-4338-98FB-AAF8FB3261BB}"/>
              </a:ext>
            </a:extLst>
          </p:cNvPr>
          <p:cNvSpPr txBox="1"/>
          <p:nvPr/>
        </p:nvSpPr>
        <p:spPr>
          <a:xfrm>
            <a:off x="538549" y="4828519"/>
            <a:ext cx="622627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. Fig 2: Organ weight in WT and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KO mice (normal and high fat diet) </a:t>
            </a:r>
          </a:p>
          <a:p>
            <a:pPr algn="just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Organ weight is unaltered in healthy and diabetic Cndp1-KO mice compared to their corresponding control group under ND (A) and HFD (B). Liver weight is increased in diabetic mice compared to their corresponding non-diabetic littermates under ND. Under HFD weight of brain, liver, lung and spleen is increased in diabetic mice compared to corresponding non-diabetic mice. Significant differences a: vs WT, b: vs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, A: vs WT HFD, B: vs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 HFD, (Two-way ANOVA with Tukey test). Group size n=10-20.</a:t>
            </a:r>
            <a:r>
              <a:rPr lang="en-GB" sz="10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3D498AD9-F3A8-49D1-9E73-51A2207E3F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081812"/>
              </p:ext>
            </p:extLst>
          </p:nvPr>
        </p:nvGraphicFramePr>
        <p:xfrm>
          <a:off x="179388" y="1951038"/>
          <a:ext cx="3379787" cy="1968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88" name="Prism 9" r:id="rId3" imgW="6920008" imgH="4034085" progId="Prism9.Document">
                  <p:embed/>
                </p:oleObj>
              </mc:Choice>
              <mc:Fallback>
                <p:oleObj name="Prism 9" r:id="rId3" imgW="6920008" imgH="4034085" progId="Prism9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id="{3D498AD9-F3A8-49D1-9E73-51A2207E3F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9388" y="1951038"/>
                        <a:ext cx="3379787" cy="1968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6521FEB4-9B10-4F9A-B79A-CC90511AC8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8681195"/>
              </p:ext>
            </p:extLst>
          </p:nvPr>
        </p:nvGraphicFramePr>
        <p:xfrm>
          <a:off x="3560763" y="1958975"/>
          <a:ext cx="3394075" cy="189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89" name="Prism 9" r:id="rId5" imgW="6887956" imgH="3842123" progId="Prism9.Document">
                  <p:embed/>
                </p:oleObj>
              </mc:Choice>
              <mc:Fallback>
                <p:oleObj name="Prism 9" r:id="rId5" imgW="6887956" imgH="3842123" progId="Prism9.Document">
                  <p:embed/>
                  <p:pic>
                    <p:nvPicPr>
                      <p:cNvPr id="6" name="Objekt 5">
                        <a:extLst>
                          <a:ext uri="{FF2B5EF4-FFF2-40B4-BE49-F238E27FC236}">
                            <a16:creationId xmlns:a16="http://schemas.microsoft.com/office/drawing/2014/main" id="{6521FEB4-9B10-4F9A-B79A-CC90511AC8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60763" y="1958975"/>
                        <a:ext cx="3394075" cy="189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feld 13">
            <a:extLst>
              <a:ext uri="{FF2B5EF4-FFF2-40B4-BE49-F238E27FC236}">
                <a16:creationId xmlns:a16="http://schemas.microsoft.com/office/drawing/2014/main" id="{AD39487C-6327-43B6-AE4F-7267607F79D6}"/>
              </a:ext>
            </a:extLst>
          </p:cNvPr>
          <p:cNvSpPr txBox="1"/>
          <p:nvPr/>
        </p:nvSpPr>
        <p:spPr>
          <a:xfrm>
            <a:off x="147455" y="164787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4BECB74-5062-4432-97AB-51B5E227EB31}"/>
              </a:ext>
            </a:extLst>
          </p:cNvPr>
          <p:cNvSpPr txBox="1"/>
          <p:nvPr/>
        </p:nvSpPr>
        <p:spPr>
          <a:xfrm>
            <a:off x="3553267" y="164787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6603235F-A80D-4763-B2E2-9A0AF9A102A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57967"/>
          <a:stretch/>
        </p:blipFill>
        <p:spPr>
          <a:xfrm>
            <a:off x="2400146" y="1718259"/>
            <a:ext cx="1809175" cy="810838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4286C73F-19DB-476B-AF24-0E389786882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6155"/>
          <a:stretch/>
        </p:blipFill>
        <p:spPr>
          <a:xfrm>
            <a:off x="5401251" y="1747664"/>
            <a:ext cx="1456749" cy="810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6495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id="{EF21CABA-017A-48E2-AC20-92BB5EE9DF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8485276"/>
              </p:ext>
            </p:extLst>
          </p:nvPr>
        </p:nvGraphicFramePr>
        <p:xfrm>
          <a:off x="4225925" y="2943225"/>
          <a:ext cx="1720850" cy="2079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48" name="Prism 9" r:id="rId3" imgW="3492196" imgH="4221286" progId="Prism9.Document">
                  <p:embed/>
                </p:oleObj>
              </mc:Choice>
              <mc:Fallback>
                <p:oleObj name="Prism 9" r:id="rId3" imgW="3492196" imgH="4221286" progId="Prism9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id="{EF21CABA-017A-48E2-AC20-92BB5EE9DF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25925" y="2943225"/>
                        <a:ext cx="1720850" cy="2079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79B0C73F-97D7-45C5-9C65-AEA6E20CE040}"/>
              </a:ext>
            </a:extLst>
          </p:cNvPr>
          <p:cNvSpPr txBox="1"/>
          <p:nvPr/>
        </p:nvSpPr>
        <p:spPr>
          <a:xfrm>
            <a:off x="297257" y="7509414"/>
            <a:ext cx="6386062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. Fig 3 Glucose homeostasis in diabetic WT and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KO mice (normal and high fat diet)</a:t>
            </a:r>
          </a:p>
          <a:p>
            <a:pPr algn="just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asting blood glucose (after 5 h fasting, A) and HbA1c (measured at week 32 of experiment, B) was increased under STZ-treatment under ND and HFD in WT and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 mice, given as mean ± SD. (Insulin treatment/per body weight (displayed as AUC of 6 different timepoints, C)  was not different for WT and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 mice under normal and high fat diet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data are displayed as mean ± SEM. </a:t>
            </a:r>
            <a:b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roup size n=10-27; For AUC insulin treatment/ body weight analysis seven timepoints, equals to fasting blood glucose measurements, were evaluated. </a:t>
            </a:r>
            <a:r>
              <a:rPr lang="en-GB" sz="1000" dirty="0"/>
              <a:t>*=</a:t>
            </a:r>
            <a:r>
              <a:rPr lang="en-GB" sz="1000" i="1" dirty="0"/>
              <a:t>p</a:t>
            </a:r>
            <a:r>
              <a:rPr lang="en-GB" sz="1000" dirty="0"/>
              <a:t>≤0.05,</a:t>
            </a:r>
            <a:r>
              <a:rPr lang="en-GB" sz="1000" i="1" dirty="0"/>
              <a:t> </a:t>
            </a:r>
            <a:r>
              <a:rPr lang="en-GB" sz="1000" dirty="0"/>
              <a:t>**=</a:t>
            </a:r>
            <a:r>
              <a:rPr lang="en-GB" sz="1000" i="1" dirty="0"/>
              <a:t>p</a:t>
            </a:r>
            <a:r>
              <a:rPr lang="en-GB" sz="1000" dirty="0"/>
              <a:t>≤0.01, ****=</a:t>
            </a:r>
            <a:r>
              <a:rPr lang="en-GB" sz="1000" i="1" dirty="0"/>
              <a:t>p</a:t>
            </a:r>
            <a:r>
              <a:rPr lang="en-GB" sz="1000" dirty="0"/>
              <a:t>&lt;0.000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one-way ANOVA with Tukey test)</a:t>
            </a: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id="{00148917-D447-4850-BBF5-92D360BA94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3942947"/>
              </p:ext>
            </p:extLst>
          </p:nvPr>
        </p:nvGraphicFramePr>
        <p:xfrm>
          <a:off x="4043363" y="4937125"/>
          <a:ext cx="1768475" cy="2152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49" name="Prism 9" r:id="rId5" imgW="3602438" imgH="4389557" progId="Prism9.Document">
                  <p:embed/>
                </p:oleObj>
              </mc:Choice>
              <mc:Fallback>
                <p:oleObj name="Prism 9" r:id="rId5" imgW="3602438" imgH="4389557" progId="Prism9.Document">
                  <p:embed/>
                  <p:pic>
                    <p:nvPicPr>
                      <p:cNvPr id="14" name="Objekt 13">
                        <a:extLst>
                          <a:ext uri="{FF2B5EF4-FFF2-40B4-BE49-F238E27FC236}">
                            <a16:creationId xmlns:a16="http://schemas.microsoft.com/office/drawing/2014/main" id="{00148917-D447-4850-BBF5-92D360BA94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43363" y="4937125"/>
                        <a:ext cx="1768475" cy="2152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id="{0094B076-B9E4-456B-8426-F10251B12D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8934433"/>
              </p:ext>
            </p:extLst>
          </p:nvPr>
        </p:nvGraphicFramePr>
        <p:xfrm>
          <a:off x="754063" y="4964113"/>
          <a:ext cx="1744662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50" name="Prism 9" r:id="rId7" imgW="3558501" imgH="4099633" progId="Prism9.Document">
                  <p:embed/>
                </p:oleObj>
              </mc:Choice>
              <mc:Fallback>
                <p:oleObj name="Prism 9" r:id="rId7" imgW="3558501" imgH="4099633" progId="Prism9.Document">
                  <p:embed/>
                  <p:pic>
                    <p:nvPicPr>
                      <p:cNvPr id="15" name="Objekt 14">
                        <a:extLst>
                          <a:ext uri="{FF2B5EF4-FFF2-40B4-BE49-F238E27FC236}">
                            <a16:creationId xmlns:a16="http://schemas.microsoft.com/office/drawing/2014/main" id="{0094B076-B9E4-456B-8426-F10251B12D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54063" y="4964113"/>
                        <a:ext cx="1744662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>
            <a:extLst>
              <a:ext uri="{FF2B5EF4-FFF2-40B4-BE49-F238E27FC236}">
                <a16:creationId xmlns:a16="http://schemas.microsoft.com/office/drawing/2014/main" id="{536059E4-6290-40C2-BBB1-BBBD4D6326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4646819"/>
              </p:ext>
            </p:extLst>
          </p:nvPr>
        </p:nvGraphicFramePr>
        <p:xfrm>
          <a:off x="900113" y="2992438"/>
          <a:ext cx="1651000" cy="192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51" name="Prism 9" r:id="rId9" imgW="3316921" imgH="3872452" progId="Prism9.Document">
                  <p:embed/>
                </p:oleObj>
              </mc:Choice>
              <mc:Fallback>
                <p:oleObj name="Prism 9" r:id="rId9" imgW="3316921" imgH="3872452" progId="Prism9.Document">
                  <p:embed/>
                  <p:pic>
                    <p:nvPicPr>
                      <p:cNvPr id="17" name="Objekt 16">
                        <a:extLst>
                          <a:ext uri="{FF2B5EF4-FFF2-40B4-BE49-F238E27FC236}">
                            <a16:creationId xmlns:a16="http://schemas.microsoft.com/office/drawing/2014/main" id="{536059E4-6290-40C2-BBB1-BBBD4D63263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00113" y="2992438"/>
                        <a:ext cx="1651000" cy="192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kt 19">
            <a:extLst>
              <a:ext uri="{FF2B5EF4-FFF2-40B4-BE49-F238E27FC236}">
                <a16:creationId xmlns:a16="http://schemas.microsoft.com/office/drawing/2014/main" id="{E8DC2270-96BD-4619-8E36-064431FE64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2247079"/>
              </p:ext>
            </p:extLst>
          </p:nvPr>
        </p:nvGraphicFramePr>
        <p:xfrm>
          <a:off x="3438525" y="1298575"/>
          <a:ext cx="3514725" cy="1489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52" name="Prism 9" r:id="rId11" imgW="6737059" imgH="2857102" progId="Prism9.Document">
                  <p:embed/>
                </p:oleObj>
              </mc:Choice>
              <mc:Fallback>
                <p:oleObj name="Prism 9" r:id="rId11" imgW="6737059" imgH="2857102" progId="Prism9.Document">
                  <p:embed/>
                  <p:pic>
                    <p:nvPicPr>
                      <p:cNvPr id="20" name="Objekt 19">
                        <a:extLst>
                          <a:ext uri="{FF2B5EF4-FFF2-40B4-BE49-F238E27FC236}">
                            <a16:creationId xmlns:a16="http://schemas.microsoft.com/office/drawing/2014/main" id="{E8DC2270-96BD-4619-8E36-064431FE64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38525" y="1298575"/>
                        <a:ext cx="3514725" cy="1489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kt 20">
            <a:extLst>
              <a:ext uri="{FF2B5EF4-FFF2-40B4-BE49-F238E27FC236}">
                <a16:creationId xmlns:a16="http://schemas.microsoft.com/office/drawing/2014/main" id="{EE44DEA0-D798-44A4-91E0-40F706CF61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8677792"/>
              </p:ext>
            </p:extLst>
          </p:nvPr>
        </p:nvGraphicFramePr>
        <p:xfrm>
          <a:off x="30163" y="1216025"/>
          <a:ext cx="3525837" cy="1573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53" name="Prism 9" r:id="rId13" imgW="6737059" imgH="3012689" progId="Prism9.Document">
                  <p:embed/>
                </p:oleObj>
              </mc:Choice>
              <mc:Fallback>
                <p:oleObj name="Prism 9" r:id="rId13" imgW="6737059" imgH="3012689" progId="Prism9.Document">
                  <p:embed/>
                  <p:pic>
                    <p:nvPicPr>
                      <p:cNvPr id="21" name="Objekt 20">
                        <a:extLst>
                          <a:ext uri="{FF2B5EF4-FFF2-40B4-BE49-F238E27FC236}">
                            <a16:creationId xmlns:a16="http://schemas.microsoft.com/office/drawing/2014/main" id="{EE44DEA0-D798-44A4-91E0-40F706CF61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0163" y="1216025"/>
                        <a:ext cx="3525837" cy="1573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feld 17">
            <a:extLst>
              <a:ext uri="{FF2B5EF4-FFF2-40B4-BE49-F238E27FC236}">
                <a16:creationId xmlns:a16="http://schemas.microsoft.com/office/drawing/2014/main" id="{9B68CF81-6DF4-483A-B26E-9A6918AFEF4A}"/>
              </a:ext>
            </a:extLst>
          </p:cNvPr>
          <p:cNvSpPr txBox="1"/>
          <p:nvPr/>
        </p:nvSpPr>
        <p:spPr>
          <a:xfrm>
            <a:off x="149620" y="97286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C975D0AA-2753-4C19-AF41-527B9662A35B}"/>
              </a:ext>
            </a:extLst>
          </p:cNvPr>
          <p:cNvSpPr txBox="1"/>
          <p:nvPr/>
        </p:nvSpPr>
        <p:spPr>
          <a:xfrm>
            <a:off x="149620" y="280280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C60FD5DC-BBF7-4335-A944-035A700C4074}"/>
              </a:ext>
            </a:extLst>
          </p:cNvPr>
          <p:cNvSpPr txBox="1"/>
          <p:nvPr/>
        </p:nvSpPr>
        <p:spPr>
          <a:xfrm>
            <a:off x="149620" y="45472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874DAC52-C954-E98A-6C3A-64CEA6305B35}"/>
              </a:ext>
            </a:extLst>
          </p:cNvPr>
          <p:cNvGrpSpPr/>
          <p:nvPr/>
        </p:nvGrpSpPr>
        <p:grpSpPr>
          <a:xfrm>
            <a:off x="2503673" y="145328"/>
            <a:ext cx="4299249" cy="814285"/>
            <a:chOff x="2503673" y="138702"/>
            <a:chExt cx="4299249" cy="814285"/>
          </a:xfrm>
        </p:grpSpPr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F2078812-2C05-C6A8-6105-59260066AC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76039" t="10492" b="52324"/>
            <a:stretch/>
          </p:blipFill>
          <p:spPr>
            <a:xfrm>
              <a:off x="5607307" y="284609"/>
              <a:ext cx="1195615" cy="617091"/>
            </a:xfrm>
            <a:prstGeom prst="rect">
              <a:avLst/>
            </a:prstGeom>
          </p:spPr>
        </p:pic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67A10DE4-35A0-7A1F-78FF-4FA9E5EE33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81117" b="51423"/>
            <a:stretch/>
          </p:blipFill>
          <p:spPr>
            <a:xfrm>
              <a:off x="2503673" y="138702"/>
              <a:ext cx="1025693" cy="81428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989035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feld 43">
            <a:extLst>
              <a:ext uri="{FF2B5EF4-FFF2-40B4-BE49-F238E27FC236}">
                <a16:creationId xmlns:a16="http://schemas.microsoft.com/office/drawing/2014/main" id="{D729B277-80AE-4338-98FB-AAF8FB3261BB}"/>
              </a:ext>
            </a:extLst>
          </p:cNvPr>
          <p:cNvSpPr txBox="1"/>
          <p:nvPr/>
        </p:nvSpPr>
        <p:spPr>
          <a:xfrm>
            <a:off x="123092" y="8076248"/>
            <a:ext cx="661181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. Fig 4: Insulin and glucose response in diabetic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KO mice (normal and high fat diet)</a:t>
            </a:r>
          </a:p>
          <a:p>
            <a:pPr algn="just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ntraperitoneal insulin tolerance (IPITT, A) and intraperitoneal glucose tolerance test (IPGTT, B) was unaltered in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 mice compared to WT mice in all treatment groups. Red dashed lines representing timespan in which significant difference between surveyed groups were detectable. Data represents estimated difference in blood glucose ± confidence band 95% (grey band). Group size n=5-10. Statistical evaluation was performed using a generalized additive model.</a:t>
            </a:r>
          </a:p>
          <a:p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96D93D66-D427-4228-92B8-134D295F86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1876123"/>
              </p:ext>
            </p:extLst>
          </p:nvPr>
        </p:nvGraphicFramePr>
        <p:xfrm>
          <a:off x="752475" y="326619"/>
          <a:ext cx="2324100" cy="180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2" name="Prism 9" r:id="rId3" imgW="3827272" imgH="2976428" progId="Prism9.Document">
                  <p:embed/>
                </p:oleObj>
              </mc:Choice>
              <mc:Fallback>
                <p:oleObj name="Prism 9" r:id="rId3" imgW="3827272" imgH="2976428" progId="Prism9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96D93D66-D427-4228-92B8-134D295F86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52475" y="326619"/>
                        <a:ext cx="2324100" cy="180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kt 26">
            <a:extLst>
              <a:ext uri="{FF2B5EF4-FFF2-40B4-BE49-F238E27FC236}">
                <a16:creationId xmlns:a16="http://schemas.microsoft.com/office/drawing/2014/main" id="{21964891-780F-40FB-ADA4-5AE7B54126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7384541"/>
              </p:ext>
            </p:extLst>
          </p:nvPr>
        </p:nvGraphicFramePr>
        <p:xfrm>
          <a:off x="752475" y="2110969"/>
          <a:ext cx="2366963" cy="1804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3" name="Prism 9" r:id="rId5" imgW="3898893" imgH="2971748" progId="Prism9.Document">
                  <p:embed/>
                </p:oleObj>
              </mc:Choice>
              <mc:Fallback>
                <p:oleObj name="Prism 9" r:id="rId5" imgW="3898893" imgH="2971748" progId="Prism9.Document">
                  <p:embed/>
                  <p:pic>
                    <p:nvPicPr>
                      <p:cNvPr id="27" name="Objekt 26">
                        <a:extLst>
                          <a:ext uri="{FF2B5EF4-FFF2-40B4-BE49-F238E27FC236}">
                            <a16:creationId xmlns:a16="http://schemas.microsoft.com/office/drawing/2014/main" id="{21964891-780F-40FB-ADA4-5AE7B54126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52475" y="2110969"/>
                        <a:ext cx="2366963" cy="1804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kt 27">
            <a:extLst>
              <a:ext uri="{FF2B5EF4-FFF2-40B4-BE49-F238E27FC236}">
                <a16:creationId xmlns:a16="http://schemas.microsoft.com/office/drawing/2014/main" id="{F1E6A9BC-80BD-49D5-954E-4D2E063711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5129490"/>
              </p:ext>
            </p:extLst>
          </p:nvPr>
        </p:nvGraphicFramePr>
        <p:xfrm>
          <a:off x="3514725" y="2109381"/>
          <a:ext cx="2376488" cy="1808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4" name="Prism 9" r:id="rId7" imgW="3914010" imgH="2976428" progId="Prism9.Document">
                  <p:embed/>
                </p:oleObj>
              </mc:Choice>
              <mc:Fallback>
                <p:oleObj name="Prism 9" r:id="rId7" imgW="3914010" imgH="2976428" progId="Prism9.Document">
                  <p:embed/>
                  <p:pic>
                    <p:nvPicPr>
                      <p:cNvPr id="28" name="Objekt 27">
                        <a:extLst>
                          <a:ext uri="{FF2B5EF4-FFF2-40B4-BE49-F238E27FC236}">
                            <a16:creationId xmlns:a16="http://schemas.microsoft.com/office/drawing/2014/main" id="{F1E6A9BC-80BD-49D5-954E-4D2E063711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14725" y="2109381"/>
                        <a:ext cx="2376488" cy="1808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B5ED676C-A417-428E-B938-8FCFA95B64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7403732"/>
              </p:ext>
            </p:extLst>
          </p:nvPr>
        </p:nvGraphicFramePr>
        <p:xfrm>
          <a:off x="3519488" y="326619"/>
          <a:ext cx="2324100" cy="180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5" name="Prism 9" r:id="rId9" imgW="3827272" imgH="2976428" progId="Prism9.Document">
                  <p:embed/>
                </p:oleObj>
              </mc:Choice>
              <mc:Fallback>
                <p:oleObj name="Prism 9" r:id="rId9" imgW="3827272" imgH="2976428" progId="Prism9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B5ED676C-A417-428E-B938-8FCFA95B64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19488" y="326619"/>
                        <a:ext cx="2324100" cy="180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kt 29">
            <a:extLst>
              <a:ext uri="{FF2B5EF4-FFF2-40B4-BE49-F238E27FC236}">
                <a16:creationId xmlns:a16="http://schemas.microsoft.com/office/drawing/2014/main" id="{20819351-9CD1-4BA3-9D4D-E222788156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1677406"/>
              </p:ext>
            </p:extLst>
          </p:nvPr>
        </p:nvGraphicFramePr>
        <p:xfrm>
          <a:off x="3514725" y="6268085"/>
          <a:ext cx="2376488" cy="1808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6" name="Prism 9" r:id="rId11" imgW="3914010" imgH="2976428" progId="Prism9.Document">
                  <p:embed/>
                </p:oleObj>
              </mc:Choice>
              <mc:Fallback>
                <p:oleObj name="Prism 9" r:id="rId11" imgW="3914010" imgH="2976428" progId="Prism9.Document">
                  <p:embed/>
                  <p:pic>
                    <p:nvPicPr>
                      <p:cNvPr id="30" name="Objekt 29">
                        <a:extLst>
                          <a:ext uri="{FF2B5EF4-FFF2-40B4-BE49-F238E27FC236}">
                            <a16:creationId xmlns:a16="http://schemas.microsoft.com/office/drawing/2014/main" id="{20819351-9CD1-4BA3-9D4D-E222788156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514725" y="6268085"/>
                        <a:ext cx="2376488" cy="1808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kt 30">
            <a:extLst>
              <a:ext uri="{FF2B5EF4-FFF2-40B4-BE49-F238E27FC236}">
                <a16:creationId xmlns:a16="http://schemas.microsoft.com/office/drawing/2014/main" id="{1828DA3C-DB9C-43B5-A4A0-A623566A8F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8589919"/>
              </p:ext>
            </p:extLst>
          </p:nvPr>
        </p:nvGraphicFramePr>
        <p:xfrm>
          <a:off x="754063" y="4457700"/>
          <a:ext cx="2363787" cy="1804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7" name="Prism 9" r:id="rId13" imgW="3892347" imgH="2973072" progId="Prism9.Document">
                  <p:embed/>
                </p:oleObj>
              </mc:Choice>
              <mc:Fallback>
                <p:oleObj name="Prism 9" r:id="rId13" imgW="3892347" imgH="2973072" progId="Prism9.Document">
                  <p:embed/>
                  <p:pic>
                    <p:nvPicPr>
                      <p:cNvPr id="31" name="Objekt 30">
                        <a:extLst>
                          <a:ext uri="{FF2B5EF4-FFF2-40B4-BE49-F238E27FC236}">
                            <a16:creationId xmlns:a16="http://schemas.microsoft.com/office/drawing/2014/main" id="{1828DA3C-DB9C-43B5-A4A0-A623566A8F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54063" y="4457700"/>
                        <a:ext cx="2363787" cy="1804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kt 31">
            <a:extLst>
              <a:ext uri="{FF2B5EF4-FFF2-40B4-BE49-F238E27FC236}">
                <a16:creationId xmlns:a16="http://schemas.microsoft.com/office/drawing/2014/main" id="{4B6554B7-D5BF-4437-AF82-AB6C57B32D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4095346"/>
              </p:ext>
            </p:extLst>
          </p:nvPr>
        </p:nvGraphicFramePr>
        <p:xfrm>
          <a:off x="752475" y="6268085"/>
          <a:ext cx="2324100" cy="1808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8" name="Prism 9" r:id="rId15" imgW="3827272" imgH="2976428" progId="Prism9.Document">
                  <p:embed/>
                </p:oleObj>
              </mc:Choice>
              <mc:Fallback>
                <p:oleObj name="Prism 9" r:id="rId15" imgW="3827272" imgH="2976428" progId="Prism9.Document">
                  <p:embed/>
                  <p:pic>
                    <p:nvPicPr>
                      <p:cNvPr id="32" name="Objekt 31">
                        <a:extLst>
                          <a:ext uri="{FF2B5EF4-FFF2-40B4-BE49-F238E27FC236}">
                            <a16:creationId xmlns:a16="http://schemas.microsoft.com/office/drawing/2014/main" id="{4B6554B7-D5BF-4437-AF82-AB6C57B32D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52475" y="6268085"/>
                        <a:ext cx="2324100" cy="1808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kt 32">
            <a:extLst>
              <a:ext uri="{FF2B5EF4-FFF2-40B4-BE49-F238E27FC236}">
                <a16:creationId xmlns:a16="http://schemas.microsoft.com/office/drawing/2014/main" id="{48536F27-1614-4C97-B783-136C9D6F75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5466289"/>
              </p:ext>
            </p:extLst>
          </p:nvPr>
        </p:nvGraphicFramePr>
        <p:xfrm>
          <a:off x="3519488" y="4458335"/>
          <a:ext cx="2366962" cy="180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89" name="Prism 9" r:id="rId17" imgW="3898893" imgH="2976428" progId="Prism9.Document">
                  <p:embed/>
                </p:oleObj>
              </mc:Choice>
              <mc:Fallback>
                <p:oleObj name="Prism 9" r:id="rId17" imgW="3898893" imgH="2976428" progId="Prism9.Document">
                  <p:embed/>
                  <p:pic>
                    <p:nvPicPr>
                      <p:cNvPr id="33" name="Objekt 32">
                        <a:extLst>
                          <a:ext uri="{FF2B5EF4-FFF2-40B4-BE49-F238E27FC236}">
                            <a16:creationId xmlns:a16="http://schemas.microsoft.com/office/drawing/2014/main" id="{48536F27-1614-4C97-B783-136C9D6F75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519488" y="4458335"/>
                        <a:ext cx="2366962" cy="180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feld 36">
            <a:extLst>
              <a:ext uri="{FF2B5EF4-FFF2-40B4-BE49-F238E27FC236}">
                <a16:creationId xmlns:a16="http://schemas.microsoft.com/office/drawing/2014/main" id="{A8DB6558-F06D-405B-9113-DC277842A9B4}"/>
              </a:ext>
            </a:extLst>
          </p:cNvPr>
          <p:cNvSpPr txBox="1"/>
          <p:nvPr/>
        </p:nvSpPr>
        <p:spPr>
          <a:xfrm>
            <a:off x="566555" y="2647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4634D2D3-D22B-4697-91E9-47FBBBFA6E85}"/>
              </a:ext>
            </a:extLst>
          </p:cNvPr>
          <p:cNvSpPr txBox="1"/>
          <p:nvPr/>
        </p:nvSpPr>
        <p:spPr>
          <a:xfrm>
            <a:off x="565920" y="462140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767233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7E121050-C471-46D7-A2DD-D7BC8FD8A1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8093" y="489121"/>
            <a:ext cx="4236923" cy="306000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DF13F5D5-BB1F-44E3-8933-6B4929BD149C}"/>
              </a:ext>
            </a:extLst>
          </p:cNvPr>
          <p:cNvSpPr txBox="1"/>
          <p:nvPr/>
        </p:nvSpPr>
        <p:spPr>
          <a:xfrm>
            <a:off x="523303" y="7297201"/>
            <a:ext cx="581139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. Fig 5: Survival probability in diabetic WT and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KO mice under normal and high fat diet</a:t>
            </a:r>
          </a:p>
          <a:p>
            <a:pPr algn="just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urvival rate (Kaplan-Meier analysis) were not different despite a transient superior survival in diabetic WT compared to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 mice did not display significant alterations between WT and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ndp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KO mice under normal (A) and high fat diet (B). Group size n = 21-23.</a:t>
            </a: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1294BF90-7BEC-4527-90EC-8EFFACB0B4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3756" y="3501319"/>
            <a:ext cx="4236924" cy="3060000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361774B1-68F5-4DE8-9C9F-AB79EA80C34C}"/>
              </a:ext>
            </a:extLst>
          </p:cNvPr>
          <p:cNvSpPr txBox="1"/>
          <p:nvPr/>
        </p:nvSpPr>
        <p:spPr>
          <a:xfrm>
            <a:off x="743059" y="57523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6B0BD5F3-A1FE-4438-919C-8193F017481E}"/>
              </a:ext>
            </a:extLst>
          </p:cNvPr>
          <p:cNvSpPr txBox="1"/>
          <p:nvPr/>
        </p:nvSpPr>
        <p:spPr>
          <a:xfrm>
            <a:off x="730965" y="35491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1075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4</Words>
  <Application>Microsoft Office PowerPoint</Application>
  <PresentationFormat>Bildschirmpräsentation (4:3)</PresentationFormat>
  <Paragraphs>24</Paragraphs>
  <Slides>5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rism 9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figures</dc:title>
  <dc:creator>Hannah Goldschmid</dc:creator>
  <cp:lastModifiedBy>Peters, Verena</cp:lastModifiedBy>
  <cp:revision>315</cp:revision>
  <cp:lastPrinted>2022-11-09T10:47:08Z</cp:lastPrinted>
  <dcterms:created xsi:type="dcterms:W3CDTF">2022-02-04T09:24:19Z</dcterms:created>
  <dcterms:modified xsi:type="dcterms:W3CDTF">2023-04-24T14:03:08Z</dcterms:modified>
</cp:coreProperties>
</file>